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>
        <p:scale>
          <a:sx n="66" d="100"/>
          <a:sy n="66" d="100"/>
        </p:scale>
        <p:origin x="-858" y="-27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F08A44A6-D0B8-468B-BFBE-A6F69353A3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xmlns="" id="{290E30C0-4426-44F2-B38D-83D7577048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917EEF46-D7EB-4D3A-AA53-615246E71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527FA636-60C8-48E8-9696-2864BB1DF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0C749B35-351D-44E4-A6A4-81EDCA1E8D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7813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547187D4-C034-4268-A707-B0B247BD28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A4623153-EC0B-470B-B21F-FE2A53E1D0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CFF63E07-8F18-406C-90E1-C1A92C393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F74D4F1B-C57A-43B9-B35B-3174569FA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81BB55B2-B5AC-43A0-A892-3D897D919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9968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xmlns="" id="{0E28F1BC-E526-4D1F-A611-9DB41941B5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xmlns="" id="{200B98A0-7387-4505-9EEB-BB9AF94866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6FC0AB7C-4E39-4C43-B52C-86823D94A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5566F087-04E0-4942-8115-E4B67FBEA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FD82129D-EA5F-4A8D-974C-9C06FC716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1874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84501D56-F7C5-4407-8FC9-5975A01B58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EA0B771E-1731-4F76-B225-D7BA4CE3AE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144FC62F-E345-405D-A2C2-243E0D6DA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89FC7273-2FD6-401E-B343-D05AF3142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00FCF9CD-4D41-40DB-A75C-93A6A7BE7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478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A5D566AA-19FB-4EDA-ACF2-F747B1EF98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6A10D460-8764-446B-969F-033E6CCE0F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4CEF4420-F4F9-4E06-B1BD-E3B5BA281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AC59A41F-927C-45F6-B849-518999A27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14B0C8A3-D83A-40CB-AE79-5A59B175F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9992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117B8BF5-0176-4913-B21A-27C31A7475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4E2B49FD-141B-4D90-B1AF-4452E44735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D91BE131-E100-4208-B3BA-52B3F22C99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84E40116-3446-4E8D-9869-E53CD626C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BA00AF64-9010-4ED4-AFB7-D429F18AA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283EC42F-9C92-47E9-982B-C2CFF707FD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4202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37CF1373-DF14-45B4-9018-8736AB74B5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8D579247-B1D6-47A7-9D19-985C637E6E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xmlns="" id="{DDFD7AE6-EB1F-45C6-8838-65AC795AB3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xmlns="" id="{7BE6424F-9AE7-40C9-A59F-7619EDEDCA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xmlns="" id="{96108778-FF81-42BF-89FE-5C56399146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xmlns="" id="{26DF539E-C698-4D2F-81F9-D1BB6FE0E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xmlns="" id="{79D5D48C-B08A-499E-B7C6-E13416A60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xmlns="" id="{E0B9C1EC-53FD-4E17-96EA-9E46EC160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745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FF706E54-0C4F-4C37-A7A1-2FEDF38C3B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xmlns="" id="{ACAE975A-AA0A-43F7-8DD3-4BC507049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xmlns="" id="{87D7E06A-DD03-45C4-B47B-DF0C56BB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xmlns="" id="{C87DC052-D687-49CE-865E-ACE25CB66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11971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xmlns="" id="{B5DBCAAF-1FA8-4F9B-8B28-3233B77E8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xmlns="" id="{CE6D0B3F-6FD4-4BCC-B726-2ECC4171B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xmlns="" id="{C0941047-D375-4F8C-BF8C-B7CF7F4A8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6608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77368569-11CF-45F2-B0D7-0E29A86E1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xmlns="" id="{20C43750-D2B9-4C51-BDD9-5631213FF4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B92072AC-78F4-4352-BC2C-A11BDC0D25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3EB2A2DE-131B-435A-9DE2-8A3553317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C08D6DBF-C49B-4826-89AB-D909E906D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D0B03701-DDC1-4241-B711-010FE74F7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9563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xmlns="" id="{1E993843-E365-4EB9-AF79-7E76C050E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xmlns="" id="{57E69F64-EBDA-4156-835B-4A8E6F200E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xmlns="" id="{9BF93EB0-19B0-4067-BB32-2E5CC68A3A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xmlns="" id="{86379981-B12D-4727-85A2-A4C767EE5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xmlns="" id="{7874F486-1666-49BA-9092-8C98A52F1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xmlns="" id="{9563C595-BCB0-4CE3-AB94-A605EE283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71407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xmlns="" id="{486395F3-D2A8-42BD-B94B-5D0E2439F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xmlns="" id="{2280C8AA-5006-48D9-9E3B-6B315E0668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xmlns="" id="{7A30CEB4-8EDE-45A6-B567-D319AB4779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xmlns="" id="{834AB917-874E-4518-AF2A-2EBF5B7CDA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xmlns="" id="{79940789-0A0B-4695-AA8B-A24B62EC7A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4807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12 CuadroTexto">
            <a:extLst>
              <a:ext uri="{FF2B5EF4-FFF2-40B4-BE49-F238E27FC236}">
                <a16:creationId xmlns:a16="http://schemas.microsoft.com/office/drawing/2014/main" xmlns="" id="{ECD1EB9D-A0AA-4739-92CE-3485885413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71600" y="5525812"/>
            <a:ext cx="9448800" cy="954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1GALT1 mRNA expression in tumor samples from the CPTAC cohort. 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1GALT1 mRNA expression in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metrioi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serous tumors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1GALT1 mRNA expression in endometrial cancer stratified by tumor grade.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1GALT1 mRNA expression in tumors demonstrating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dometrioid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istology and stratified by tumor grade. Significance p values were calculated using t-test. ns = not significant.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es-E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26" name="Picture 2" descr="C:\Users\Rodrigo\Desktop\Rodrigo Notebook\Articulos\Tesis Ana Montero\C1GALT1\Cellular Oncology\Reviewer Responses\Supplementary Fig 1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35680" y="317148"/>
            <a:ext cx="5120640" cy="51206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290835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0</TotalTime>
  <Words>3</Words>
  <Application>Microsoft Office PowerPoint</Application>
  <PresentationFormat>Personalizado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MONTERO CALLE</dc:creator>
  <cp:lastModifiedBy>Rodrigo BM</cp:lastModifiedBy>
  <cp:revision>12</cp:revision>
  <dcterms:created xsi:type="dcterms:W3CDTF">2022-01-24T20:56:41Z</dcterms:created>
  <dcterms:modified xsi:type="dcterms:W3CDTF">2022-10-22T09:23:49Z</dcterms:modified>
</cp:coreProperties>
</file>